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0" autoAdjust="0"/>
    <p:restoredTop sz="94660"/>
  </p:normalViewPr>
  <p:slideViewPr>
    <p:cSldViewPr snapToGrid="0">
      <p:cViewPr varScale="1">
        <p:scale>
          <a:sx n="92" d="100"/>
          <a:sy n="92" d="100"/>
        </p:scale>
        <p:origin x="18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7D0377-9DA9-3472-9B5A-26AF6A2BAC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95ECDFC-1C1C-FACE-7B9F-12959109DF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1FFF42-BC3E-0775-DE1C-3C2097645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71E7EE-3768-B896-AE0B-8F47E287C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794EEA-BE46-169F-FF5F-0BA2C6251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264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8E5304-A4DC-2875-50F1-9CA7DA42E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62F7DA-4111-DEC7-17D2-C0DB82F09B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EFC8C4-A2A7-E89F-8ED9-EF6876BFC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4B1E31-85ED-4B83-F9B9-DFA22A3C4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D67D89-5725-1FCE-4A2E-D38707EF9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39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D3FD959-BFED-FE91-1C76-D60A03BB38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4A613A-58DE-C262-DAD3-64236D0F53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BDDA8F-C108-C690-AF79-1C4878C5E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54CB5C-93E7-728D-EF4C-36201D402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80575F-BA28-6099-D20D-8B61D7ED9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127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87A3C4-6BED-D883-2525-197B380BB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B05FC6-570D-757D-2479-29C5E4CF13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ECFD6C-7CC8-45FF-395F-93B16D734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BAAD21-00CF-7353-CBF8-29C68D28D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0F46C0-6D0C-074E-6875-6165A96D4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378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23BDBE-B101-2F05-4930-48E4D1F95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893DBF-23DC-F84B-F621-5F9F097EF5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5B62E6-FA34-41BC-00A7-2133BE3A5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D8DA9F-9207-932D-0312-E3D11DE36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A9B00C-59ED-33E4-4778-FDB8D6F5E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63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C0DF4F-A2D5-25B9-1C64-512CCCB13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8A6D92-DEDA-29ED-3B3E-4CE945588C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BA1C5F9-095F-6C0A-93AD-5F954645B8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83A04C-FAF8-E273-13F2-8D37CA624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79AFBC-1FDA-9DB4-51FE-6AA7486C6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89B36D-409E-9AFA-36BA-9711CF633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572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1EDD2B-CA15-FDA7-26D5-E64687DA8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082002-85AD-A84C-5CD0-D7BC899FB6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F834E5B-F671-4B1D-821A-391A709EB0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A0EB095-0294-03BD-819B-53BF20A096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EFE610C-3DC7-7C14-07F6-7A75FE319D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517EC51-07B1-EB54-1BCE-CCF1D658F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CD80A05-700E-9008-97C9-F4151FB32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5FE7AAD-D5D4-6E55-A0AB-DE489D7E2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93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FD7D05-A4FB-6270-9CDF-52FFBA058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7642F46-93F0-A225-A94F-3096C4CFD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7DA6F55-7405-3C1B-E3EA-54B72FA91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FA47955-35C9-F66E-F651-A86D557B9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39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262E3B5-EBB8-9207-77E9-67D904FE7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5D4AB5-DA7E-4B26-4DB2-BCBDE9A9F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50C032E-D7B4-30A2-142A-1C7DD9E46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453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80052C-DB38-AD5F-F524-7D77B85F1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F536E1-28EB-8D86-352A-76C29B02DE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5576851-7981-FD44-B98A-E02C76ABD4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5E491BD-D40C-BE52-C4E6-EDB940F81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1E01E7-BC32-66AE-A1B2-2DB8F1BF1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1A77785-3133-8BA9-8F0B-AAD55D5C5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44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ED6A13-DCED-49E1-4679-C8068F804C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B4F917-6A75-D18C-0570-B1F79A91D6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48008F8-CA72-26FE-D6D3-54C36C8DB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C4C145-DE7D-20F0-5BFE-B45628F78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ED90E9-0893-1137-90CC-7587DD389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613CC7-C518-5275-C026-F04BF61B9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336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7DCC4DA-EF2C-7F4F-5E74-FCCFC4247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0E2892-7366-F41F-B028-FE6A818CB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1E2FFB-B61B-E3E6-CE2D-F210DB911C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BBE19-D5D3-467A-B5E0-876BA04F37C2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FB457E-28EE-ABCE-AD3C-95A6FB1467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CA7AB8-D748-840C-F220-02A4E8F07C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22480-1206-4C1B-A23E-C0295F1DF4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4976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2DEE3D9-BECB-8C44-536B-7C6D4ABCAB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911" y="201666"/>
            <a:ext cx="3762033" cy="291731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973C05A-1ECD-C29D-1690-061A86EFA6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4983" y="201666"/>
            <a:ext cx="3762034" cy="295999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89D005D-DCAF-329D-64DF-B9E05C44DE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8067" y="261184"/>
            <a:ext cx="3762033" cy="296604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27BC18A-9580-A69F-C69F-D217324907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8911" y="3227231"/>
            <a:ext cx="3762033" cy="304783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3FE2316-2CDF-1C8F-E8A8-FEE595F9101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14983" y="3227231"/>
            <a:ext cx="3762033" cy="303361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E994FF4-67CF-EADD-C5FB-976DCDC7F4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01183" y="3429000"/>
            <a:ext cx="3708917" cy="2930667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CB9D7C6D-D028-B426-E651-67DC0C07FF3B}"/>
              </a:ext>
            </a:extLst>
          </p:cNvPr>
          <p:cNvSpPr txBox="1"/>
          <p:nvPr/>
        </p:nvSpPr>
        <p:spPr>
          <a:xfrm>
            <a:off x="1201243" y="6412150"/>
            <a:ext cx="107088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Figure S1 Number of pericarditis reports with 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bDMARDs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in AS, using data from the FAERS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331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B317721-24D9-CD4F-A5FB-057A3F6F44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083" y="144203"/>
            <a:ext cx="3734809" cy="306314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160BE1C-6C2F-86DA-3731-69CB54F2EE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960" y="164808"/>
            <a:ext cx="3734809" cy="308374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A49F73E-C1A0-B31E-8AB9-0BBB3C106E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1838" y="164808"/>
            <a:ext cx="3734809" cy="317798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0CB3A9C-A53E-E365-914C-BD707E6428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8041" y="3248555"/>
            <a:ext cx="4010891" cy="321651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E1A6979-D9DE-AFDB-6682-C8146169D0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32000" y="3207345"/>
            <a:ext cx="3734809" cy="321647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9C8FF70-E603-640C-5DD5-4090D85B5F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49877" y="3515210"/>
            <a:ext cx="3596770" cy="2957928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7465E93D-91A2-C1C1-C8B0-E9408BC2A556}"/>
              </a:ext>
            </a:extLst>
          </p:cNvPr>
          <p:cNvSpPr txBox="1"/>
          <p:nvPr/>
        </p:nvSpPr>
        <p:spPr>
          <a:xfrm>
            <a:off x="1526958" y="6522511"/>
            <a:ext cx="93448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S2 Number of pericarditis reports with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bDMARDs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in AS, using data from the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Eudravigilanc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7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32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uang Xia</dc:creator>
  <cp:lastModifiedBy>Shuang Xia</cp:lastModifiedBy>
  <cp:revision>11</cp:revision>
  <dcterms:created xsi:type="dcterms:W3CDTF">2023-12-19T03:08:50Z</dcterms:created>
  <dcterms:modified xsi:type="dcterms:W3CDTF">2023-12-19T03:53:01Z</dcterms:modified>
</cp:coreProperties>
</file>